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38" y="3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DCB7D0-8EEC-4C84-AE51-BB7202CEE3B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92965CE-2A52-43DF-8B30-652C762626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0F7D0E-E7C5-4056-BACE-39987C1F0F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241FE-92C0-49F2-B12C-729DFE8F4C52}" type="datetimeFigureOut">
              <a:rPr lang="en-US" smtClean="0"/>
              <a:t>7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BE9BB2-47ED-4223-B905-189895C7B1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8DC24C-7427-41B7-9C04-AE50B32706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42224-18B9-4351-A138-879719E7AB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90941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5C3EA8-F3B2-45E6-9EA5-B5889E84E8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4CF6B57-504F-4B81-B9D7-0C89AA18CE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6D1ACF-19A9-4A82-AC82-C9472DC5CE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241FE-92C0-49F2-B12C-729DFE8F4C52}" type="datetimeFigureOut">
              <a:rPr lang="en-US" smtClean="0"/>
              <a:t>7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0C5CF9-3AD9-4AB1-B43A-B2CFADA653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51D56E-A9B8-49C2-BDF6-A58252BAB7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42224-18B9-4351-A138-879719E7AB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3958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873459C-1744-40A1-8613-F832C49913C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6DAEFE0-B8D5-4924-B6F5-113A9B38BC3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F2FC60-F976-4EAA-93D6-820434C611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241FE-92C0-49F2-B12C-729DFE8F4C52}" type="datetimeFigureOut">
              <a:rPr lang="en-US" smtClean="0"/>
              <a:t>7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44BF1D-9338-4AC8-BED3-EF97D7B3F3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021A71-05EC-4581-B98A-D56436743E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42224-18B9-4351-A138-879719E7AB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6944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C8E69C-79B6-44D1-BA23-00198D20B9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876F8C1-054B-4B1F-A6FF-7652038D22D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12E2F8-D649-4436-A972-DDE9B9B5FA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241FE-92C0-49F2-B12C-729DFE8F4C52}" type="datetimeFigureOut">
              <a:rPr lang="en-US" smtClean="0"/>
              <a:t>7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E26DEE-C18D-4961-8EAF-26F478690F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F36F7D-495A-448C-9DD9-007728140D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42224-18B9-4351-A138-879719E7AB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11935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9558AD-D240-4EF7-8BC7-578868C3B5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2BC75B-EC5B-478E-99FC-8828132365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EBEADE-DDD2-404A-97F6-2A8E182248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241FE-92C0-49F2-B12C-729DFE8F4C52}" type="datetimeFigureOut">
              <a:rPr lang="en-US" smtClean="0"/>
              <a:t>7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12401C-138B-4BED-BFBB-133A5F8D12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C27040-9643-41BC-AE1A-9E792F5C97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42224-18B9-4351-A138-879719E7AB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26497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14E3F5-4EC2-4083-BC4F-8AEDD0A8CD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C87AF2-2AD5-42DE-8FA3-F11990C3721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9EF73BC-6A7A-4DA7-BA01-26F28FC329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A6B2FE-3F79-4D98-9AC8-84BDEF1C81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241FE-92C0-49F2-B12C-729DFE8F4C52}" type="datetimeFigureOut">
              <a:rPr lang="en-US" smtClean="0"/>
              <a:t>7/2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F90F98-49B9-47A8-BD3B-9DBB75D52C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1E9431-B67A-484E-A061-F277BEA61B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42224-18B9-4351-A138-879719E7AB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4180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3CA070-77B9-424A-8FA1-B2A7961900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09983B4-6BC8-4BFF-87E3-349AA8E1AB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B7D82BB-F68F-42AE-A0BF-BFDBDE1555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3378F42-1F07-46E0-9F94-6DA7682B927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BA2C8A6-8421-4670-A4ED-E9F4640B481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14BD942-E489-4A0F-B31B-30DAAC4EA9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241FE-92C0-49F2-B12C-729DFE8F4C52}" type="datetimeFigureOut">
              <a:rPr lang="en-US" smtClean="0"/>
              <a:t>7/22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4AF48E9-9965-4489-AB6A-1C96560B71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5766927-84D8-4FDA-83DD-45F446DC9A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42224-18B9-4351-A138-879719E7AB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69041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7671D4-D5C7-4D25-8492-EE1B6397D1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A7AB207-C215-4066-99F9-23EA5AD91D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241FE-92C0-49F2-B12C-729DFE8F4C52}" type="datetimeFigureOut">
              <a:rPr lang="en-US" smtClean="0"/>
              <a:t>7/22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A564B93-59D8-4A55-901B-729FEA1489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92EFE17-E49F-43AE-BD89-03E69C622B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42224-18B9-4351-A138-879719E7AB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1869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2F38A3A-ED3B-44C0-A8EC-6002E4DE12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241FE-92C0-49F2-B12C-729DFE8F4C52}" type="datetimeFigureOut">
              <a:rPr lang="en-US" smtClean="0"/>
              <a:t>7/22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8400D93-F77E-4E93-91E7-9943430DEE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254FEC6-D7F1-4737-ADA8-E54CCC303F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42224-18B9-4351-A138-879719E7AB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8238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74E604-7408-44E9-8E60-87EFA69DCD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B52287-A6AA-4919-9FEF-0BB21FC5DE8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7B698F8-04AD-434A-98F9-FE034B7DF6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4D8A66-80CC-4476-A53F-18CC62A4ED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241FE-92C0-49F2-B12C-729DFE8F4C52}" type="datetimeFigureOut">
              <a:rPr lang="en-US" smtClean="0"/>
              <a:t>7/2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4F80A50-71B7-4E4F-B606-4ABB8B847C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70A8032-CE08-4E99-9B7C-942900E7AA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42224-18B9-4351-A138-879719E7AB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16754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239950-35D7-4B89-9485-A5504BBD16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DD4EAE3-FE45-40C7-9FA1-66AFF674987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9B488D3-9FA3-4D92-982B-8ECA72B82D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49AF67-882B-4186-B332-EAEC8CC016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B241FE-92C0-49F2-B12C-729DFE8F4C52}" type="datetimeFigureOut">
              <a:rPr lang="en-US" smtClean="0"/>
              <a:t>7/2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044CC1-CB23-4A7D-9974-B2D9818328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D2405C-0140-4644-8072-FC5C0235F5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442224-18B9-4351-A138-879719E7AB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4481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7DB54A1-4274-488A-8208-740316D560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8473EAC-3796-4FC6-8B06-65AF29C384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294D35-4734-4EA7-9CE8-6560A5379FF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B241FE-92C0-49F2-B12C-729DFE8F4C52}" type="datetimeFigureOut">
              <a:rPr lang="en-US" smtClean="0"/>
              <a:t>7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17F3E5-2C0A-4C4A-98A2-955BAB5B8F8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ADCD91-E953-47C6-A835-2453D91D554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442224-18B9-4351-A138-879719E7AB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36468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3581C395-5F0E-4817-AE88-AD3BBF5B092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51640650"/>
              </p:ext>
            </p:extLst>
          </p:nvPr>
        </p:nvGraphicFramePr>
        <p:xfrm>
          <a:off x="212124" y="1216989"/>
          <a:ext cx="11767752" cy="3767188"/>
        </p:xfrm>
        <a:graphic>
          <a:graphicData uri="http://schemas.openxmlformats.org/drawingml/2006/table">
            <a:tbl>
              <a:tblPr firstRow="1" firstCol="1" bandRow="1"/>
              <a:tblGrid>
                <a:gridCol w="3249828">
                  <a:extLst>
                    <a:ext uri="{9D8B030D-6E8A-4147-A177-3AD203B41FA5}">
                      <a16:colId xmlns:a16="http://schemas.microsoft.com/office/drawing/2014/main" val="4281409949"/>
                    </a:ext>
                  </a:extLst>
                </a:gridCol>
                <a:gridCol w="1425146">
                  <a:extLst>
                    <a:ext uri="{9D8B030D-6E8A-4147-A177-3AD203B41FA5}">
                      <a16:colId xmlns:a16="http://schemas.microsoft.com/office/drawing/2014/main" val="531129222"/>
                    </a:ext>
                  </a:extLst>
                </a:gridCol>
                <a:gridCol w="6037462">
                  <a:extLst>
                    <a:ext uri="{9D8B030D-6E8A-4147-A177-3AD203B41FA5}">
                      <a16:colId xmlns:a16="http://schemas.microsoft.com/office/drawing/2014/main" val="287699261"/>
                    </a:ext>
                  </a:extLst>
                </a:gridCol>
                <a:gridCol w="1055316">
                  <a:extLst>
                    <a:ext uri="{9D8B030D-6E8A-4147-A177-3AD203B41FA5}">
                      <a16:colId xmlns:a16="http://schemas.microsoft.com/office/drawing/2014/main" val="165632035"/>
                    </a:ext>
                  </a:extLst>
                </a:gridCol>
              </a:tblGrid>
              <a:tr h="46365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b="1" dirty="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ame of the qPCR assay/target gene</a:t>
                      </a:r>
                      <a:endParaRPr lang="nb-NO" sz="16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b="1" dirty="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rimer/probe</a:t>
                      </a:r>
                      <a:endParaRPr lang="nb-NO" sz="16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b="1" dirty="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equence (5’-3’)</a:t>
                      </a:r>
                      <a:endParaRPr lang="nb-NO" sz="16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b="1" dirty="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mplicon size</a:t>
                      </a:r>
                      <a:endParaRPr lang="nb-NO" sz="16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0884505"/>
                  </a:ext>
                </a:extLst>
              </a:tr>
              <a:tr h="226548">
                <a:tc row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L1 /L. salmonis mitochondrial rRNA</a:t>
                      </a:r>
                      <a:endParaRPr lang="nb-NO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orward</a:t>
                      </a:r>
                      <a:endParaRPr lang="nb-NO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TTACGCGCTGTTATCCCTAAG</a:t>
                      </a:r>
                      <a:endParaRPr lang="nb-NO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28 bp</a:t>
                      </a:r>
                      <a:endParaRPr lang="nb-NO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5321925"/>
                  </a:ext>
                </a:extLst>
              </a:tr>
              <a:tr h="2265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everse</a:t>
                      </a:r>
                      <a:endParaRPr lang="nb-NO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ACGATAAGACCCTAAGACCTTTAC</a:t>
                      </a:r>
                      <a:endParaRPr lang="nb-NO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00006289"/>
                  </a:ext>
                </a:extLst>
              </a:tr>
              <a:tr h="2265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robe</a:t>
                      </a:r>
                      <a:endParaRPr lang="nb-NO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/56-FAM/TAAGTGGGC/ZEN/TATCCCAGCCAAACA/3IABkFQ/</a:t>
                      </a:r>
                      <a:endParaRPr lang="nb-NO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18624229"/>
                  </a:ext>
                </a:extLst>
              </a:tr>
              <a:tr h="226548">
                <a:tc row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L2/ L. salmonis mitochondrial rRNA</a:t>
                      </a:r>
                      <a:endParaRPr lang="nb-NO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orward</a:t>
                      </a:r>
                      <a:endParaRPr lang="nb-NO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CATCGAGGTCACGAATATCTTT</a:t>
                      </a:r>
                      <a:endParaRPr lang="nb-NO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49 bp</a:t>
                      </a:r>
                      <a:endParaRPr lang="nb-NO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96370580"/>
                  </a:ext>
                </a:extLst>
              </a:tr>
              <a:tr h="2265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everse</a:t>
                      </a:r>
                      <a:endParaRPr lang="nb-NO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ACCTTGTTTGGCTGGGATAG</a:t>
                      </a:r>
                      <a:endParaRPr lang="nb-NO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43114863"/>
                  </a:ext>
                </a:extLst>
              </a:tr>
              <a:tr h="2265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robe</a:t>
                      </a:r>
                      <a:endParaRPr lang="nb-NO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/56-FAM/ACGCGCTGT/ZEN/TATCCCTAAGGTACC/3IABkFQ/</a:t>
                      </a:r>
                      <a:endParaRPr lang="nb-NO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09027751"/>
                  </a:ext>
                </a:extLst>
              </a:tr>
              <a:tr h="226548">
                <a:tc row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L3/ 18S ribosomal RNA gene</a:t>
                      </a:r>
                      <a:endParaRPr lang="nb-NO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orward</a:t>
                      </a:r>
                      <a:endParaRPr lang="nb-NO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GATACCGCCCTAGTTCTAAC</a:t>
                      </a:r>
                      <a:endParaRPr lang="nb-NO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9 bp</a:t>
                      </a:r>
                      <a:endParaRPr lang="nb-NO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6932268"/>
                  </a:ext>
                </a:extLst>
              </a:tr>
              <a:tr h="2265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everse</a:t>
                      </a:r>
                      <a:endParaRPr lang="nb-NO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TTCCCGCAGAGTCGTAAA</a:t>
                      </a:r>
                      <a:endParaRPr lang="nb-NO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800796"/>
                  </a:ext>
                </a:extLst>
              </a:tr>
              <a:tr h="2265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robe</a:t>
                      </a:r>
                      <a:endParaRPr lang="nb-NO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/56-FAM/CCAGCTAGC/ZEN/GATCCGCAGTTGTTTA/3IABkFQ/</a:t>
                      </a:r>
                      <a:endParaRPr lang="nb-NO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36260718"/>
                  </a:ext>
                </a:extLst>
              </a:tr>
              <a:tr h="226548">
                <a:tc row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C/Cytochrome c oxidase (CO1),</a:t>
                      </a:r>
                      <a:endParaRPr lang="nb-NO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McBeath et al., 2006</a:t>
                      </a:r>
                      <a:endParaRPr lang="nb-NO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orward</a:t>
                      </a:r>
                      <a:endParaRPr lang="nb-NO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GACATAGCTTTCCCCCGCTTA</a:t>
                      </a:r>
                      <a:endParaRPr lang="nb-NO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02 bp</a:t>
                      </a:r>
                      <a:endParaRPr lang="nb-NO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5351254"/>
                  </a:ext>
                </a:extLst>
              </a:tr>
              <a:tr h="22654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Reverse</a:t>
                      </a:r>
                      <a:endParaRPr lang="nb-NO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AGTTCCTGCACCACTTTCTACTAATG</a:t>
                      </a:r>
                      <a:endParaRPr lang="nb-NO" sz="16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01890812"/>
                  </a:ext>
                </a:extLst>
              </a:tr>
              <a:tr h="51465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robe</a:t>
                      </a:r>
                      <a:endParaRPr lang="nb-NO" sz="16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600" dirty="0">
                          <a:solidFill>
                            <a:srgbClr val="000000"/>
                          </a:solidFill>
                          <a:effectLst/>
                          <a:latin typeface="CMR8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/56-FAM/ACCCTCTTTGAGTTTATTACT/MGB/</a:t>
                      </a:r>
                    </a:p>
                  </a:txBody>
                  <a:tcPr marL="27057" marR="27057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3442372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865198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21</Words>
  <Application>Microsoft Office PowerPoint</Application>
  <PresentationFormat>Widescreen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MR8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riana Krolicka</dc:creator>
  <cp:lastModifiedBy>Adriana Krolicka</cp:lastModifiedBy>
  <cp:revision>2</cp:revision>
  <dcterms:created xsi:type="dcterms:W3CDTF">2022-07-22T12:56:55Z</dcterms:created>
  <dcterms:modified xsi:type="dcterms:W3CDTF">2022-07-22T13:03:57Z</dcterms:modified>
</cp:coreProperties>
</file>